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/>
    <p:restoredTop sz="82313"/>
  </p:normalViewPr>
  <p:slideViewPr>
    <p:cSldViewPr snapToGrid="0">
      <p:cViewPr varScale="1">
        <p:scale>
          <a:sx n="100" d="100"/>
          <a:sy n="100" d="100"/>
        </p:scale>
        <p:origin x="1488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45903C-8B8C-C244-8D71-D7234DE389D6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4A034B-D414-FF47-BFDB-D7ACC97BE0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77351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4A034B-D414-FF47-BFDB-D7ACC97BE08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014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7C08C81-B15D-E8F3-63AD-B972C59013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06FD581-729A-B40D-0680-712F9649F7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C5B899-35F2-FA9B-610F-1E882D4ED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719C23-01F8-1AC9-967F-94D642012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FBEA87-7F5B-7C1D-382B-7F74287FA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839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88F089-630F-6B2F-31D5-CF96187DE0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0163FCD-7B91-2A00-B2F6-1B455917B9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54B8AD4-59EB-B6D2-DCC4-A8C3B8D3A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B79DA4A-F73C-180B-4427-F775AE06C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5B3100-0825-F6E1-AF8C-F896DC26C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766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CCE5E55-511B-1CA3-04D8-1D4F8D02D6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3FE390D-617D-97C7-13A5-1ECA6C5966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C29DD73-0591-8C16-8F94-4453A5C14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DCD8D2-0D4D-0300-FA26-B261DF95D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40F219-D800-F0EB-6569-AE0FDA9F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6280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276EB4-1D64-AF98-9B37-EEEE5D9B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E77695D-0274-FD34-84EE-792D28A3AE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CE5D2C9-E221-AA1A-A48F-6CA05C8F2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608223B-CE9D-3609-F012-A60F6976C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7F202E4-04BA-FFAC-670A-F17D9A781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3133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07EA639-8561-58C9-C1BF-0F34BC2F34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E189A4A-582F-6BA9-F34F-63007A1C11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A5DCA5D-EA39-847B-3FB0-A2429C08B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002581-0B8C-603F-DAC0-7EC040858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C517771-E004-4D5E-3287-0985F5F5C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277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B3D80A-BB70-30BC-BC99-2F24615A9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82FB62-EC29-243C-5748-2E884A5344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B4D9325-1BFB-7BF5-A0A2-EF26F80D8B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E5EB4E3-CE6A-5643-96A8-70388B10F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DFB02BA-9005-5078-002B-F9661DAB5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49EE6A3-A78A-BC5E-19ED-293BB44C2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757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570C35-DE13-1BB5-B69B-69E615529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C69FADB-1AA0-B981-3ABE-D35EF60CD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8E7D7F5-C10C-C8B2-D8E5-04E38C7D13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22461A0-895F-F8D6-3476-9D96330CF1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C83291A-A18B-D653-9534-5C079AB6DD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6A546D0-4191-3F53-903E-4525C3976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573D520-4F6D-71E3-3E7B-7118C74EF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1868781-E5ED-F930-4ADF-0E23D93DA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75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AE35300-563D-EDE0-44C5-446EB2CACF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5929351-0656-3641-BE35-F645AA907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368B770-1664-D45F-4BD9-B5C2C5293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7AA8EDCF-1238-9258-7B94-67297F1C1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650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FB0C30D-BB53-15DF-9ABD-CBD038883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FDE3857-8070-E58C-88F0-795A905CC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9A40649-7AD1-1710-A381-1D58CAA05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7791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87DA76-0C61-08D2-2AF8-2B8054712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3E18DAA-0615-B48A-1570-543D895B42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EE9B1E2-CE0E-C1F5-2996-5E8A1542FF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C647F83-3DC6-FC61-604A-CDFDF105A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684DBFC-8C30-7173-D417-3D7D86550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FFC5F97-394F-11AC-9C14-C6AA208DE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7267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035827-ABB4-4ABF-2824-C3DD41CDB8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5038C9A-481D-2EA6-7FE5-C78517A624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C9491EA-1356-191D-5DF3-E9F8691DC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99AFE7B-AA7B-8359-BD8D-46A7C933E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4BC68D5-8CED-A136-F755-4762D4D01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1B685A-5507-00AF-D9D7-580063C1B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667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5026CEA-2386-C4FE-790F-C8E7E2253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15F410B-C354-2861-B99A-BADBD82FC1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9E72830-1C1C-02FC-AF62-0E3436104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0001E-C3EE-4E41-8104-9E8900339DA9}" type="datetimeFigureOut">
              <a:rPr lang="fr-FR" smtClean="0"/>
              <a:t>12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AE2BD64-8513-CBB7-D2FF-762AE16159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20440D-8F27-BF53-545D-FE2F5FBCBA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56956-394E-164A-9B01-1ED1280184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052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39">
            <a:extLst>
              <a:ext uri="{FF2B5EF4-FFF2-40B4-BE49-F238E27FC236}">
                <a16:creationId xmlns:a16="http://schemas.microsoft.com/office/drawing/2014/main" id="{5EF088B7-3DF1-CEE7-2877-A8B035143479}"/>
              </a:ext>
            </a:extLst>
          </p:cNvPr>
          <p:cNvSpPr/>
          <p:nvPr/>
        </p:nvSpPr>
        <p:spPr>
          <a:xfrm>
            <a:off x="0" y="2264258"/>
            <a:ext cx="12192000" cy="126282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E0D32C4-BE02-474E-10CC-F160CCA86E3D}"/>
              </a:ext>
            </a:extLst>
          </p:cNvPr>
          <p:cNvSpPr/>
          <p:nvPr/>
        </p:nvSpPr>
        <p:spPr>
          <a:xfrm>
            <a:off x="0" y="448767"/>
            <a:ext cx="12192000" cy="60942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21A0F8AD-0115-C3FF-3A5C-C117A31A7859}"/>
              </a:ext>
            </a:extLst>
          </p:cNvPr>
          <p:cNvSpPr txBox="1"/>
          <p:nvPr/>
        </p:nvSpPr>
        <p:spPr>
          <a:xfrm>
            <a:off x="36945" y="524123"/>
            <a:ext cx="16563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rapeutic are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1E228B5F-3E11-ECAF-B39B-35D17A9D51E1}"/>
              </a:ext>
            </a:extLst>
          </p:cNvPr>
          <p:cNvSpPr txBox="1"/>
          <p:nvPr/>
        </p:nvSpPr>
        <p:spPr>
          <a:xfrm>
            <a:off x="3650770" y="524123"/>
            <a:ext cx="20409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Compound/institution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52C5BA2-C801-53FA-72AA-96EDB6BD5A72}"/>
              </a:ext>
            </a:extLst>
          </p:cNvPr>
          <p:cNvSpPr txBox="1"/>
          <p:nvPr/>
        </p:nvSpPr>
        <p:spPr>
          <a:xfrm>
            <a:off x="1685693" y="524123"/>
            <a:ext cx="18437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Associated disease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D3A47434-C43D-7A5A-84B2-F62E5E828FFE}"/>
              </a:ext>
            </a:extLst>
          </p:cNvPr>
          <p:cNvSpPr txBox="1"/>
          <p:nvPr/>
        </p:nvSpPr>
        <p:spPr>
          <a:xfrm>
            <a:off x="5815492" y="524123"/>
            <a:ext cx="1114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RNA target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AF4ECCE-0717-E49F-921F-DE3CCCB380F0}"/>
              </a:ext>
            </a:extLst>
          </p:cNvPr>
          <p:cNvSpPr txBox="1"/>
          <p:nvPr/>
        </p:nvSpPr>
        <p:spPr>
          <a:xfrm>
            <a:off x="7492884" y="524123"/>
            <a:ext cx="1444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Mode of action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4EA59EF9-8929-B4A8-BE36-0953433923F8}"/>
              </a:ext>
            </a:extLst>
          </p:cNvPr>
          <p:cNvSpPr txBox="1"/>
          <p:nvPr/>
        </p:nvSpPr>
        <p:spPr>
          <a:xfrm>
            <a:off x="9299114" y="524122"/>
            <a:ext cx="20425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Stage of development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8123042-6EB0-B702-CDD2-4D34A36B05AB}"/>
              </a:ext>
            </a:extLst>
          </p:cNvPr>
          <p:cNvSpPr txBox="1"/>
          <p:nvPr/>
        </p:nvSpPr>
        <p:spPr>
          <a:xfrm>
            <a:off x="11486972" y="524121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Ref.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C4E529A-68BE-6F98-4154-619495151D85}"/>
              </a:ext>
            </a:extLst>
          </p:cNvPr>
          <p:cNvSpPr txBox="1"/>
          <p:nvPr/>
        </p:nvSpPr>
        <p:spPr>
          <a:xfrm>
            <a:off x="36945" y="1078103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ncology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09CCBB40-80D4-09AA-38DF-2C1EC1FB2AEC}"/>
              </a:ext>
            </a:extLst>
          </p:cNvPr>
          <p:cNvSpPr txBox="1"/>
          <p:nvPr/>
        </p:nvSpPr>
        <p:spPr>
          <a:xfrm>
            <a:off x="36944" y="2286835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Neurology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CCBF1AB6-41E1-7ADA-6F07-5BF07461F8AC}"/>
              </a:ext>
            </a:extLst>
          </p:cNvPr>
          <p:cNvSpPr txBox="1"/>
          <p:nvPr/>
        </p:nvSpPr>
        <p:spPr>
          <a:xfrm>
            <a:off x="3650770" y="1078103"/>
            <a:ext cx="211400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Zotatifin (eFT226)/eFFECTOR Therapeutics &amp; Inception Therapeutics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F605CC0-B17F-29D0-554C-9A816CA6DF7D}"/>
              </a:ext>
            </a:extLst>
          </p:cNvPr>
          <p:cNvSpPr txBox="1"/>
          <p:nvPr/>
        </p:nvSpPr>
        <p:spPr>
          <a:xfrm>
            <a:off x="1685693" y="1078103"/>
            <a:ext cx="19763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Triple-negative breast cancer and chronic myelogenous leukaemi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2D5969F7-015C-28F6-2164-0150961CB21C}"/>
              </a:ext>
            </a:extLst>
          </p:cNvPr>
          <p:cNvSpPr txBox="1"/>
          <p:nvPr/>
        </p:nvSpPr>
        <p:spPr>
          <a:xfrm>
            <a:off x="5815492" y="1078103"/>
            <a:ext cx="16773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olypurine sequences in the 5′UTR of a subset of oncogenic mRNAs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535AC14D-16D3-90EC-C4BC-026A51A9EA15}"/>
              </a:ext>
            </a:extLst>
          </p:cNvPr>
          <p:cNvSpPr txBox="1"/>
          <p:nvPr/>
        </p:nvSpPr>
        <p:spPr>
          <a:xfrm>
            <a:off x="7492900" y="1078102"/>
            <a:ext cx="197636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Inhibits translation initiation by clamping eIF4A to polypurine RNA sequence in the 5′UTR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C22E2CF-73AD-98B1-AFA5-662C925B36A1}"/>
              </a:ext>
            </a:extLst>
          </p:cNvPr>
          <p:cNvSpPr txBox="1"/>
          <p:nvPr/>
        </p:nvSpPr>
        <p:spPr>
          <a:xfrm>
            <a:off x="9299114" y="1078102"/>
            <a:ext cx="161701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hase I–II clinical trial: NCT04092673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1111D622-9970-CDE1-1D86-1D73F9F60187}"/>
              </a:ext>
            </a:extLst>
          </p:cNvPr>
          <p:cNvSpPr txBox="1"/>
          <p:nvPr/>
        </p:nvSpPr>
        <p:spPr>
          <a:xfrm>
            <a:off x="11486972" y="1078102"/>
            <a:ext cx="690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[104]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8FBC08A4-9C43-473A-7C1F-B301CE0E3CB0}"/>
              </a:ext>
            </a:extLst>
          </p:cNvPr>
          <p:cNvSpPr txBox="1"/>
          <p:nvPr/>
        </p:nvSpPr>
        <p:spPr>
          <a:xfrm>
            <a:off x="3650770" y="2281912"/>
            <a:ext cx="21140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Risdiplam/Roche and PTC Therapeutics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A41767A9-2D96-DDB6-741D-BFD3CDC6CEC7}"/>
              </a:ext>
            </a:extLst>
          </p:cNvPr>
          <p:cNvSpPr txBox="1"/>
          <p:nvPr/>
        </p:nvSpPr>
        <p:spPr>
          <a:xfrm>
            <a:off x="1685693" y="2281912"/>
            <a:ext cx="19763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930D8092-3D2D-6003-6675-FF4756F7EB79}"/>
              </a:ext>
            </a:extLst>
          </p:cNvPr>
          <p:cNvSpPr txBox="1"/>
          <p:nvPr/>
        </p:nvSpPr>
        <p:spPr>
          <a:xfrm>
            <a:off x="5815492" y="2281912"/>
            <a:ext cx="12258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SMN2 pre-mRNA exon 7–intron junction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37F7B727-9D34-E90A-F78E-2CDD67623046}"/>
              </a:ext>
            </a:extLst>
          </p:cNvPr>
          <p:cNvSpPr txBox="1"/>
          <p:nvPr/>
        </p:nvSpPr>
        <p:spPr>
          <a:xfrm>
            <a:off x="7492900" y="2281911"/>
            <a:ext cx="173199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omotes exon inclusion by stabilizing the binding of the splicing machinery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7CA30612-81A4-0176-E9C6-5A99EABA4105}"/>
              </a:ext>
            </a:extLst>
          </p:cNvPr>
          <p:cNvSpPr txBox="1"/>
          <p:nvPr/>
        </p:nvSpPr>
        <p:spPr>
          <a:xfrm>
            <a:off x="9299114" y="2281911"/>
            <a:ext cx="161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FDA approved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3E8EA2FE-17FC-AEA8-EC7A-BA8C6DA7CBCE}"/>
              </a:ext>
            </a:extLst>
          </p:cNvPr>
          <p:cNvSpPr txBox="1"/>
          <p:nvPr/>
        </p:nvSpPr>
        <p:spPr>
          <a:xfrm>
            <a:off x="11486971" y="2278160"/>
            <a:ext cx="690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[93]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BDF39799-96D9-E55C-930B-79122B824A21}"/>
              </a:ext>
            </a:extLst>
          </p:cNvPr>
          <p:cNvSpPr txBox="1"/>
          <p:nvPr/>
        </p:nvSpPr>
        <p:spPr>
          <a:xfrm>
            <a:off x="3662059" y="3544737"/>
            <a:ext cx="21140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Branapla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52236990-83F4-3961-F9C4-9EF630248E33}"/>
              </a:ext>
            </a:extLst>
          </p:cNvPr>
          <p:cNvSpPr txBox="1"/>
          <p:nvPr/>
        </p:nvSpPr>
        <p:spPr>
          <a:xfrm>
            <a:off x="1693886" y="3535573"/>
            <a:ext cx="19763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7DFDC283-D0F3-D486-8D02-8CD4B05081C6}"/>
              </a:ext>
            </a:extLst>
          </p:cNvPr>
          <p:cNvSpPr txBox="1"/>
          <p:nvPr/>
        </p:nvSpPr>
        <p:spPr>
          <a:xfrm>
            <a:off x="5814175" y="3544737"/>
            <a:ext cx="12258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MN2 pre-mRNA exon 7–intron junction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448CE66B-D4C6-7739-B9C2-83DD794F7491}"/>
              </a:ext>
            </a:extLst>
          </p:cNvPr>
          <p:cNvSpPr txBox="1"/>
          <p:nvPr/>
        </p:nvSpPr>
        <p:spPr>
          <a:xfrm>
            <a:off x="7492900" y="3535799"/>
            <a:ext cx="173199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omotes exon inclusion by stabilizing the binding of the splicing machinery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7919B2B6-D0A3-51B8-DE48-E620738FB2A0}"/>
              </a:ext>
            </a:extLst>
          </p:cNvPr>
          <p:cNvSpPr txBox="1"/>
          <p:nvPr/>
        </p:nvSpPr>
        <p:spPr>
          <a:xfrm>
            <a:off x="9299114" y="3543687"/>
            <a:ext cx="161701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hase I/II clinical trial (for SMA: NCT02268552; for HD: NCT05111249)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616E6F0F-33A6-4533-CD01-B0041248A0CB}"/>
              </a:ext>
            </a:extLst>
          </p:cNvPr>
          <p:cNvSpPr txBox="1"/>
          <p:nvPr/>
        </p:nvSpPr>
        <p:spPr>
          <a:xfrm>
            <a:off x="11536374" y="3535573"/>
            <a:ext cx="690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[94]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4CBB855D-AC51-CBC3-BECF-B80EBB7FBC39}"/>
              </a:ext>
            </a:extLst>
          </p:cNvPr>
          <p:cNvSpPr txBox="1"/>
          <p:nvPr/>
        </p:nvSpPr>
        <p:spPr>
          <a:xfrm>
            <a:off x="36944" y="35294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Neurology</a:t>
            </a:r>
          </a:p>
        </p:txBody>
      </p:sp>
    </p:spTree>
    <p:extLst>
      <p:ext uri="{BB962C8B-B14F-4D97-AF65-F5344CB8AC3E}">
        <p14:creationId xmlns:p14="http://schemas.microsoft.com/office/powerpoint/2010/main" val="39639212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146</Words>
  <Application>Microsoft Macintosh PowerPoint</Application>
  <PresentationFormat>Grand écran</PresentationFormat>
  <Paragraphs>2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 BOLLOT SYNSIGHT</dc:creator>
  <cp:lastModifiedBy>Guillaume BOLLOT SYNSIGHT</cp:lastModifiedBy>
  <cp:revision>16</cp:revision>
  <dcterms:created xsi:type="dcterms:W3CDTF">2023-08-01T13:49:31Z</dcterms:created>
  <dcterms:modified xsi:type="dcterms:W3CDTF">2023-10-12T09:44:52Z</dcterms:modified>
</cp:coreProperties>
</file>